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8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35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466" autoAdjust="0"/>
    <p:restoredTop sz="94660"/>
  </p:normalViewPr>
  <p:slideViewPr>
    <p:cSldViewPr snapToGrid="0">
      <p:cViewPr varScale="1">
        <p:scale>
          <a:sx n="63" d="100"/>
          <a:sy n="63" d="100"/>
        </p:scale>
        <p:origin x="516" y="48"/>
      </p:cViewPr>
      <p:guideLst>
        <p:guide orient="horz" pos="935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33DEDC3-CEFD-1F87-C272-1ACC5867AF9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34C6AEF-F40B-B42D-4AB1-8E943369B4F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CF5E848-70E0-2736-E770-FFDE53557E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578AE-E661-4279-8723-640413A86004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51E1BB8-EEA0-D192-DB7F-BB48DCDD1D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E555AA6-F25C-40EF-D976-06E953180B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54C0C-7177-49E8-81A8-1FF7B0C50D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41811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1D8EB0A-8A91-9BBA-DA90-48986714A7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E63AC8D-3058-F3E9-550D-1420D62475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32E877E-B7A5-6D65-5D6C-555D2C221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578AE-E661-4279-8723-640413A86004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B439ADC-F7EF-AEFD-066A-2A954B8AC2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A1B35CA-9810-48D0-8AA5-51825FC35B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54C0C-7177-49E8-81A8-1FF7B0C50D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07021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8EDC21D-1A17-FFE4-595C-3820B7DE016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95CB64C-629D-A1CA-1124-DE595D4CA6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9FB9D1E-5147-DAD1-6D43-4573F0A7F8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578AE-E661-4279-8723-640413A86004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B8EE09C-77EB-1A65-608A-D5745C35CF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3A6D3EE-3C6B-2CAC-2FC9-C57374544F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54C0C-7177-49E8-81A8-1FF7B0C50D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13803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46F076A-6E74-4723-B465-D01A65C0ED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44384FA-0005-DCFF-A68C-93C4674D36E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752F40C-FFE3-F32B-04DC-809A58E81C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578AE-E661-4279-8723-640413A86004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DBF7C49-0269-2389-1AD9-6D91132E57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CC85C20-9E64-C6DF-538D-090BD9E81C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54C0C-7177-49E8-81A8-1FF7B0C50D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12577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539E4F1-ADBC-A60C-BEA7-1D8E6AF273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07324D0-6260-185D-5CDB-6E1D39E3D4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C0540CE-D8E5-F00F-BF30-4488BDF844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578AE-E661-4279-8723-640413A86004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6E98AFA-9623-A932-0F49-DADB164221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EDF3B8C-8D52-D7BD-2514-C40BCE8240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54C0C-7177-49E8-81A8-1FF7B0C50D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7346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5D832BB-2147-439D-7430-FC4664EDE0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291AF73-84E7-FF09-45B9-C91BEF224AD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7AD9DC0-65A4-76E6-9E4E-EF572FFD0E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14C81C0-B079-D48D-0BCD-5188416C4A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578AE-E661-4279-8723-640413A86004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3B04784-04CB-BDA3-42A2-10FB2A7C7D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E5296EC-6C6D-C55B-9532-2240A16375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54C0C-7177-49E8-81A8-1FF7B0C50D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06186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6C31FF0-A2DD-A8CE-3BB9-F83CFCEBB1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C1EA734-5248-4F52-AD47-41CA2AD770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ADC8745-28B8-83DA-B783-F65E90FD00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3408460D-45AC-D548-5F6C-CDBB11FBDE5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9A3DABC-4F5F-6849-5743-5AE032ACD23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7E35CFE-4759-3CC1-BF4F-FFFBDE1380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578AE-E661-4279-8723-640413A86004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B458FAD-ABA2-0F59-85D6-DE07727086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2EE5B333-8F62-0EA4-789D-0E549C5525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54C0C-7177-49E8-81A8-1FF7B0C50D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89282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F67AA43-40C1-C407-101C-0AC827CE76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77CCEF8-CE9C-D3D0-B4FA-68DD618150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578AE-E661-4279-8723-640413A86004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F2B94401-A0DB-866C-8BE4-9A67210AF8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C1DA383-FE7D-10F9-4F54-1DF0727BF2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54C0C-7177-49E8-81A8-1FF7B0C50D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7948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65BD95B-9090-C8E0-05CB-290B547CC7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578AE-E661-4279-8723-640413A86004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806767C-1958-1641-A0FB-CDA351C92E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A94F154-A87C-AB24-79F3-B5AC4FC503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54C0C-7177-49E8-81A8-1FF7B0C50D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647937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AA915B8-16D9-A85D-C49D-1F9B02B4D2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E11D310-06A0-626E-AC91-413DE04EC7F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DBE8BF6-7A68-42F4-47AC-7607D3062C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996CA1F-B2F9-F676-AAE3-8DC7C4ACDB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578AE-E661-4279-8723-640413A86004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0DA7FD0-2C15-71A0-1C47-09F8687B9F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A3B2AC1-9F49-A664-A7D8-4C5C924ABF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54C0C-7177-49E8-81A8-1FF7B0C50D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9797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DA0A31F-43EC-227E-2543-256E5E3850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F9145EA-8B33-A20C-9420-F46CF0D5D23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E5816CC-15A2-4783-AE12-0F7A889546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D411D93-36D3-B33B-39FD-4551FB93E7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578AE-E661-4279-8723-640413A86004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43E4D6A-07CB-90AC-8B2F-9BF46E4AA7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841EAD2-22E6-360F-2B00-BC3C2DFF8B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54C0C-7177-49E8-81A8-1FF7B0C50D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47387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932B70B-B81F-9656-80DE-9FD2EE5F14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187E1D6-6FA1-AB63-DA77-2B3E85294A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DE8ED58-37AE-F9B8-A288-763382D5DE1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5578AE-E661-4279-8723-640413A86004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805E57A-16ED-B34F-14C8-1D813050BBE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55A9E6E-E70B-8005-873B-425CCDF69C6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A54C0C-7177-49E8-81A8-1FF7B0C50D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57440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mp4"/><Relationship Id="rId7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2.xml"/><Relationship Id="rId4" Type="http://schemas.openxmlformats.org/officeDocument/2006/relationships/video" Target="../media/media2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56F219B-1FEC-6BFA-FD6E-7FCCB74F318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202505041645090017CARD">
            <a:hlinkClick r:id="" action="ppaction://media"/>
            <a:extLst>
              <a:ext uri="{FF2B5EF4-FFF2-40B4-BE49-F238E27FC236}">
                <a16:creationId xmlns:a16="http://schemas.microsoft.com/office/drawing/2014/main" id="{56FBAC4F-48A3-AC58-77A2-1226F917B8E6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580964" y="1482826"/>
            <a:ext cx="5305407" cy="3831388"/>
          </a:xfrm>
          <a:prstGeom prst="rect">
            <a:avLst/>
          </a:prstGeom>
        </p:spPr>
      </p:pic>
      <p:pic>
        <p:nvPicPr>
          <p:cNvPr id="7" name="202505081904570192CARD">
            <a:hlinkClick r:id="" action="ppaction://media"/>
            <a:extLst>
              <a:ext uri="{FF2B5EF4-FFF2-40B4-BE49-F238E27FC236}">
                <a16:creationId xmlns:a16="http://schemas.microsoft.com/office/drawing/2014/main" id="{A320850A-BDE4-4497-EB9D-0EC7C012BC53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6337319" y="1482826"/>
            <a:ext cx="5305407" cy="3831683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3A7FA194-1BFE-4C0E-D6E5-B1181CD70DB9}"/>
              </a:ext>
            </a:extLst>
          </p:cNvPr>
          <p:cNvSpPr/>
          <p:nvPr/>
        </p:nvSpPr>
        <p:spPr>
          <a:xfrm>
            <a:off x="307438" y="1292678"/>
            <a:ext cx="5770880" cy="53848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8D1191BD-6B68-2DB5-4621-1C537F8FD0E8}"/>
              </a:ext>
            </a:extLst>
          </p:cNvPr>
          <p:cNvSpPr/>
          <p:nvPr/>
        </p:nvSpPr>
        <p:spPr>
          <a:xfrm>
            <a:off x="6096000" y="1292678"/>
            <a:ext cx="5770880" cy="53848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12B68367-211E-01E2-FF42-88FB961F764F}"/>
              </a:ext>
            </a:extLst>
          </p:cNvPr>
          <p:cNvSpPr txBox="1"/>
          <p:nvPr/>
        </p:nvSpPr>
        <p:spPr>
          <a:xfrm>
            <a:off x="2697302" y="1221216"/>
            <a:ext cx="10727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 1</a:t>
            </a:r>
            <a:endParaRPr lang="zh-CN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E414C047-BA8C-8493-DC72-D1F44BF5011B}"/>
              </a:ext>
            </a:extLst>
          </p:cNvPr>
          <p:cNvSpPr txBox="1"/>
          <p:nvPr/>
        </p:nvSpPr>
        <p:spPr>
          <a:xfrm>
            <a:off x="8453657" y="1221216"/>
            <a:ext cx="10727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 1</a:t>
            </a:r>
            <a:endParaRPr lang="zh-CN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202505041645090017CARD">
            <a:hlinkClick r:id="" action="ppaction://media"/>
            <a:extLst>
              <a:ext uri="{FF2B5EF4-FFF2-40B4-BE49-F238E27FC236}">
                <a16:creationId xmlns:a16="http://schemas.microsoft.com/office/drawing/2014/main" id="{C8EFF4F4-4AC3-C277-F111-44CC415A7D46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580964" y="1451295"/>
            <a:ext cx="5305407" cy="3831388"/>
          </a:xfrm>
          <a:prstGeom prst="rect">
            <a:avLst/>
          </a:prstGeom>
        </p:spPr>
      </p:pic>
      <p:pic>
        <p:nvPicPr>
          <p:cNvPr id="14" name="202505081904570192CARD">
            <a:hlinkClick r:id="" action="ppaction://media"/>
            <a:extLst>
              <a:ext uri="{FF2B5EF4-FFF2-40B4-BE49-F238E27FC236}">
                <a16:creationId xmlns:a16="http://schemas.microsoft.com/office/drawing/2014/main" id="{C157C6FD-0904-584F-440E-071E1C692278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6337319" y="1451295"/>
            <a:ext cx="5305407" cy="3831683"/>
          </a:xfrm>
          <a:prstGeom prst="rect">
            <a:avLst/>
          </a:prstGeom>
        </p:spPr>
      </p:pic>
      <p:sp>
        <p:nvSpPr>
          <p:cNvPr id="15" name="矩形 14">
            <a:extLst>
              <a:ext uri="{FF2B5EF4-FFF2-40B4-BE49-F238E27FC236}">
                <a16:creationId xmlns:a16="http://schemas.microsoft.com/office/drawing/2014/main" id="{82D5F23F-96E3-3034-24C8-1560FE2B3687}"/>
              </a:ext>
            </a:extLst>
          </p:cNvPr>
          <p:cNvSpPr/>
          <p:nvPr/>
        </p:nvSpPr>
        <p:spPr>
          <a:xfrm>
            <a:off x="307438" y="1261147"/>
            <a:ext cx="5770880" cy="53848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56953B5D-EA34-2242-74B5-9DBBAF6952AE}"/>
              </a:ext>
            </a:extLst>
          </p:cNvPr>
          <p:cNvSpPr/>
          <p:nvPr/>
        </p:nvSpPr>
        <p:spPr>
          <a:xfrm>
            <a:off x="6096000" y="1261147"/>
            <a:ext cx="5770880" cy="53848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2FF5251F-842A-DE14-6777-8BEEA7E8EBA5}"/>
              </a:ext>
            </a:extLst>
          </p:cNvPr>
          <p:cNvSpPr txBox="1"/>
          <p:nvPr/>
        </p:nvSpPr>
        <p:spPr>
          <a:xfrm>
            <a:off x="2697302" y="1189685"/>
            <a:ext cx="10727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 0</a:t>
            </a:r>
            <a:endParaRPr lang="zh-CN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EE73FEC8-5E45-98B3-DC55-BC62F049D21A}"/>
              </a:ext>
            </a:extLst>
          </p:cNvPr>
          <p:cNvSpPr txBox="1"/>
          <p:nvPr/>
        </p:nvSpPr>
        <p:spPr>
          <a:xfrm>
            <a:off x="8453657" y="1189685"/>
            <a:ext cx="10727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 4</a:t>
            </a:r>
            <a:endParaRPr lang="zh-CN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8D0DCD20-BFB9-912E-9260-1C7D52A7C626}"/>
              </a:ext>
            </a:extLst>
          </p:cNvPr>
          <p:cNvSpPr txBox="1"/>
          <p:nvPr/>
        </p:nvSpPr>
        <p:spPr>
          <a:xfrm>
            <a:off x="144878" y="172720"/>
            <a:ext cx="6096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36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 Light" panose="02010600030101010101" pitchFamily="2" charset="-122"/>
                <a:cs typeface="Times New Roman" panose="02020603050405020304" pitchFamily="18" charset="0"/>
              </a:rPr>
              <a:t>Supplementary video 1</a:t>
            </a:r>
            <a:endParaRPr lang="en-US" altLang="zh-CN" sz="3600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43EDE257-C7AE-A5FD-2759-042CE9A6498E}"/>
              </a:ext>
            </a:extLst>
          </p:cNvPr>
          <p:cNvSpPr txBox="1"/>
          <p:nvPr/>
        </p:nvSpPr>
        <p:spPr>
          <a:xfrm>
            <a:off x="33121" y="964575"/>
            <a:ext cx="554960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4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224D4526-7900-F05B-15DC-AB2AB4DBDA5E}"/>
              </a:ext>
            </a:extLst>
          </p:cNvPr>
          <p:cNvSpPr txBox="1"/>
          <p:nvPr/>
        </p:nvSpPr>
        <p:spPr>
          <a:xfrm>
            <a:off x="5825738" y="963335"/>
            <a:ext cx="52610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4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00F36525-C915-31C1-16ED-52D79EBBCBD9}"/>
              </a:ext>
            </a:extLst>
          </p:cNvPr>
          <p:cNvSpPr txBox="1"/>
          <p:nvPr/>
        </p:nvSpPr>
        <p:spPr>
          <a:xfrm>
            <a:off x="547437" y="5539482"/>
            <a:ext cx="1106176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. video 1 </a:t>
            </a:r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pical four-chamber view demonstrating diffuse reduction in myocardial contractility, consistent with septic cardiomyopathy. (</a:t>
            </a:r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dirty="0"/>
              <a:t> </a:t>
            </a:r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d recovery of cardiac function on day 4 of V-A ECMO support.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141925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035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3035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3069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10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1" dur="3035" fill="hold"/>
                                        <p:tgtEl>
                                          <p:spTgt spid="1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2" fill="hold">
                            <p:stCondLst>
                              <p:cond delay="6104"/>
                            </p:stCondLst>
                            <p:childTnLst>
                              <p:par>
                                <p:cTn id="13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4" dur="3069" fill="hold"/>
                                        <p:tgtEl>
                                          <p:spTgt spid="1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15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6" fill="hold">
                      <p:stCondLst>
                        <p:cond delay="0"/>
                      </p:stCondLst>
                      <p:childTnLst>
                        <p:par>
                          <p:cTn id="17" fill="hold">
                            <p:stCondLst>
                              <p:cond delay="0"/>
                            </p:stCondLst>
                            <p:childTnLst>
                              <p:par>
                                <p:cTn id="18" presetID="2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9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20" repeatCount="indefinite" fill="remove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video>
              <p:cMediaNode vol="80000">
                <p:cTn id="21" repeatCount="indefinite" fill="remove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  <p:seq concurrent="1" nextAc="seek">
              <p:cTn id="22" restart="whenNotActive" fill="hold" evtFilter="cancelBubble" nodeType="interactiveSeq">
                <p:stCondLst>
                  <p:cond evt="onClick" delay="0">
                    <p:tgtEl>
                      <p:spTgt spid="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3" fill="hold">
                      <p:stCondLst>
                        <p:cond delay="0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6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7"/>
                  </p:tgtEl>
                </p:cond>
              </p:nextCondLst>
            </p:seq>
            <p:seq concurrent="1" nextAc="seek">
              <p:cTn id="27" restart="whenNotActive" fill="hold" evtFilter="cancelBubble" nodeType="interactiveSeq">
                <p:stCondLst>
                  <p:cond evt="onClick" delay="0">
                    <p:tgtEl>
                      <p:spTgt spid="1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8" fill="hold">
                      <p:stCondLst>
                        <p:cond delay="0"/>
                      </p:stCondLst>
                      <p:childTnLst>
                        <p:par>
                          <p:cTn id="29" fill="hold">
                            <p:stCondLst>
                              <p:cond delay="0"/>
                            </p:stCondLst>
                            <p:childTnLst>
                              <p:par>
                                <p:cTn id="30" presetID="2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1" dur="1" fill="hold"/>
                                        <p:tgtEl>
                                          <p:spTgt spid="1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3"/>
                  </p:tgtEl>
                </p:cond>
              </p:nextCondLst>
            </p:seq>
            <p:seq concurrent="1" nextAc="seek">
              <p:cTn id="32" restart="whenNotActive" fill="hold" evtFilter="cancelBubble" nodeType="interactiveSeq">
                <p:stCondLst>
                  <p:cond evt="onClick" delay="0">
                    <p:tgtEl>
                      <p:spTgt spid="1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3" fill="hold">
                      <p:stCondLst>
                        <p:cond delay="0"/>
                      </p:stCondLst>
                      <p:childTnLst>
                        <p:par>
                          <p:cTn id="34" fill="hold">
                            <p:stCondLst>
                              <p:cond delay="0"/>
                            </p:stCondLst>
                            <p:childTnLst>
                              <p:par>
                                <p:cTn id="3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6" dur="1" fill="hold"/>
                                        <p:tgtEl>
                                          <p:spTgt spid="1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4"/>
                  </p:tgtEl>
                </p:cond>
              </p:nextCondLst>
            </p:seq>
            <p:video>
              <p:cMediaNode vol="80000">
                <p:cTn id="37" repeatCount="indefinite" fill="remove" display="0">
                  <p:stCondLst>
                    <p:cond delay="indefinite"/>
                  </p:stCondLst>
                </p:cTn>
                <p:tgtEl>
                  <p:spTgt spid="13"/>
                </p:tgtEl>
              </p:cMediaNode>
            </p:video>
            <p:video>
              <p:cMediaNode vol="80000">
                <p:cTn id="38" repeatCount="indefinite" fill="remove" display="0">
                  <p:stCondLst>
                    <p:cond delay="indefinite"/>
                  </p:stCondLst>
                </p:cTn>
                <p:tgtEl>
                  <p:spTgt spid="14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10</TotalTime>
  <Words>51</Words>
  <Application>Microsoft Office PowerPoint</Application>
  <PresentationFormat>宽屏</PresentationFormat>
  <Paragraphs>8</Paragraphs>
  <Slides>1</Slides>
  <Notes>0</Notes>
  <HiddenSlides>0</HiddenSlides>
  <MMClips>4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重症 协和</dc:creator>
  <cp:lastModifiedBy>贻敏 薛</cp:lastModifiedBy>
  <cp:revision>35</cp:revision>
  <dcterms:created xsi:type="dcterms:W3CDTF">2025-03-10T06:33:19Z</dcterms:created>
  <dcterms:modified xsi:type="dcterms:W3CDTF">2025-07-27T13:47:15Z</dcterms:modified>
</cp:coreProperties>
</file>